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  <p:sldId id="259" r:id="rId4"/>
    <p:sldId id="263" r:id="rId5"/>
    <p:sldId id="260" r:id="rId6"/>
    <p:sldId id="256" r:id="rId7"/>
    <p:sldId id="264" r:id="rId8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5785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0711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1521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6552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9985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6183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1203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2257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5772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5131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1935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65C75-E5DE-44B2-BC6C-D8FF7073F337}" type="datetimeFigureOut">
              <a:rPr lang="ko-KR" altLang="en-US" smtClean="0"/>
              <a:t>2024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F0FBB-8978-44C2-A874-0A8B5C7340A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2142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3" Type="http://schemas.openxmlformats.org/officeDocument/2006/relationships/image" Target="../media/image5.tiff"/><Relationship Id="rId7" Type="http://schemas.openxmlformats.org/officeDocument/2006/relationships/image" Target="../media/image9.jpe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eg"/><Relationship Id="rId3" Type="http://schemas.openxmlformats.org/officeDocument/2006/relationships/image" Target="../media/image23.png"/><Relationship Id="rId7" Type="http://schemas.openxmlformats.org/officeDocument/2006/relationships/image" Target="../media/image27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jpeg"/><Relationship Id="rId5" Type="http://schemas.openxmlformats.org/officeDocument/2006/relationships/image" Target="../media/image25.jpeg"/><Relationship Id="rId4" Type="http://schemas.openxmlformats.org/officeDocument/2006/relationships/image" Target="../media/image2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jpeg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그림 1" descr="162821A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4938" y="1174345"/>
            <a:ext cx="4692498" cy="2346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38">
            <a:extLst>
              <a:ext uri="{FF2B5EF4-FFF2-40B4-BE49-F238E27FC236}">
                <a16:creationId xmlns:a16="http://schemas.microsoft.com/office/drawing/2014/main" id="{D1AA24D9-D7F2-41C5-4713-E26C14A7F900}"/>
              </a:ext>
            </a:extLst>
          </p:cNvPr>
          <p:cNvSpPr txBox="1"/>
          <p:nvPr/>
        </p:nvSpPr>
        <p:spPr>
          <a:xfrm>
            <a:off x="0" y="0"/>
            <a:ext cx="12192000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.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ropped (A) and uncropped (B) blots confirming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3 expression upon treatment with three custom-designed SIRT3 siRNAs and scramble control. The #3 siRNA was selected for subsequent experiments.</a:t>
            </a:r>
            <a:endParaRPr lang="en-US" altLang="ko-KR" sz="1000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100" dirty="0">
                <a:latin typeface="맑은 고딕" panose="020B0503020000020004" pitchFamily="50" charset="-127"/>
                <a:cs typeface="Times New Roman" panose="02020603050405020304" pitchFamily="18" charset="0"/>
              </a:rPr>
              <a:t> </a:t>
            </a:r>
            <a:endParaRPr lang="en-US" altLang="ko-KR" sz="2400" dirty="0">
              <a:latin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108"/>
          <a:stretch/>
        </p:blipFill>
        <p:spPr>
          <a:xfrm>
            <a:off x="7441891" y="1804921"/>
            <a:ext cx="2735798" cy="1863053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879"/>
          <a:stretch/>
        </p:blipFill>
        <p:spPr>
          <a:xfrm>
            <a:off x="7441891" y="3998100"/>
            <a:ext cx="2735798" cy="1433064"/>
          </a:xfrm>
          <a:prstGeom prst="rect">
            <a:avLst/>
          </a:prstGeom>
        </p:spPr>
      </p:pic>
      <p:sp>
        <p:nvSpPr>
          <p:cNvPr id="7" name="오른쪽 화살표 6"/>
          <p:cNvSpPr/>
          <p:nvPr/>
        </p:nvSpPr>
        <p:spPr>
          <a:xfrm flipH="1">
            <a:off x="9388336" y="3031664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오른쪽 화살표 7"/>
          <p:cNvSpPr/>
          <p:nvPr/>
        </p:nvSpPr>
        <p:spPr>
          <a:xfrm flipH="1">
            <a:off x="9532336" y="4672398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FAE5ABA-2145-4D53-B3D9-9F02CC79F295}"/>
              </a:ext>
            </a:extLst>
          </p:cNvPr>
          <p:cNvSpPr txBox="1"/>
          <p:nvPr/>
        </p:nvSpPr>
        <p:spPr>
          <a:xfrm>
            <a:off x="968066" y="1174345"/>
            <a:ext cx="4201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AE5ABA-2145-4D53-B3D9-9F02CC79F295}"/>
              </a:ext>
            </a:extLst>
          </p:cNvPr>
          <p:cNvSpPr txBox="1"/>
          <p:nvPr/>
        </p:nvSpPr>
        <p:spPr>
          <a:xfrm>
            <a:off x="7041801" y="1174345"/>
            <a:ext cx="4201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105902" y="1543311"/>
            <a:ext cx="1431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RT3 mitochondria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105902" y="3736490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SP60 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2333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내용 개체 틀 6">
            <a:extLst>
              <a:ext uri="{FF2B5EF4-FFF2-40B4-BE49-F238E27FC236}">
                <a16:creationId xmlns:a16="http://schemas.microsoft.com/office/drawing/2014/main" id="{BF7DF4C1-41CF-470A-88F7-95098D42846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8" t="23155" r="42035" b="62097"/>
          <a:stretch/>
        </p:blipFill>
        <p:spPr>
          <a:xfrm>
            <a:off x="183862" y="1371956"/>
            <a:ext cx="3947563" cy="1838106"/>
          </a:xfrm>
          <a:prstGeom prst="rect">
            <a:avLst/>
          </a:prstGeom>
        </p:spPr>
      </p:pic>
      <p:pic>
        <p:nvPicPr>
          <p:cNvPr id="4" name="내용 개체 틀 6">
            <a:extLst>
              <a:ext uri="{FF2B5EF4-FFF2-40B4-BE49-F238E27FC236}">
                <a16:creationId xmlns:a16="http://schemas.microsoft.com/office/drawing/2014/main" id="{0EE1E230-F4D7-4F5B-AE2F-639B49516C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" t="37907" r="40358" b="56753"/>
          <a:stretch/>
        </p:blipFill>
        <p:spPr>
          <a:xfrm>
            <a:off x="106738" y="3452972"/>
            <a:ext cx="4024687" cy="599576"/>
          </a:xfrm>
          <a:prstGeom prst="rect">
            <a:avLst/>
          </a:prstGeom>
        </p:spPr>
      </p:pic>
      <p:pic>
        <p:nvPicPr>
          <p:cNvPr id="5" name="내용 개체 틀 6">
            <a:extLst>
              <a:ext uri="{FF2B5EF4-FFF2-40B4-BE49-F238E27FC236}">
                <a16:creationId xmlns:a16="http://schemas.microsoft.com/office/drawing/2014/main" id="{92660141-B0E1-49BE-B365-45486887AF8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5" t="47298" r="44806" b="47119"/>
          <a:stretch/>
        </p:blipFill>
        <p:spPr>
          <a:xfrm>
            <a:off x="259406" y="4424565"/>
            <a:ext cx="3872019" cy="687460"/>
          </a:xfrm>
          <a:prstGeom prst="rect">
            <a:avLst/>
          </a:prstGeom>
        </p:spPr>
      </p:pic>
      <p:pic>
        <p:nvPicPr>
          <p:cNvPr id="6" name="내용 개체 틀 6">
            <a:extLst>
              <a:ext uri="{FF2B5EF4-FFF2-40B4-BE49-F238E27FC236}">
                <a16:creationId xmlns:a16="http://schemas.microsoft.com/office/drawing/2014/main" id="{AA3D5BC2-AAE4-4A50-B027-76C9D216AF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6" t="62254" r="41692" b="29121"/>
          <a:stretch/>
        </p:blipFill>
        <p:spPr>
          <a:xfrm>
            <a:off x="183862" y="5489028"/>
            <a:ext cx="3947563" cy="88430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5260" y="1371956"/>
            <a:ext cx="3499992" cy="1450567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6402" y="3160621"/>
            <a:ext cx="3458460" cy="1362090"/>
          </a:xfrm>
          <a:prstGeom prst="rect">
            <a:avLst/>
          </a:prstGeom>
        </p:spPr>
      </p:pic>
      <p:sp>
        <p:nvSpPr>
          <p:cNvPr id="9" name="テキスト ボックス 38">
            <a:extLst>
              <a:ext uri="{FF2B5EF4-FFF2-40B4-BE49-F238E27FC236}">
                <a16:creationId xmlns:a16="http://schemas.microsoft.com/office/drawing/2014/main" id="{D1AA24D9-D7F2-41C5-4713-E26C14A7F900}"/>
              </a:ext>
            </a:extLst>
          </p:cNvPr>
          <p:cNvSpPr txBox="1"/>
          <p:nvPr/>
        </p:nvSpPr>
        <p:spPr>
          <a:xfrm>
            <a:off x="0" y="6009"/>
            <a:ext cx="8834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.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ginal blots of westerns 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ko-KR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ko-KR" altLang="en-US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A &amp; 1B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US" altLang="ja-JP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오른쪽 화살표 9"/>
          <p:cNvSpPr/>
          <p:nvPr/>
        </p:nvSpPr>
        <p:spPr>
          <a:xfrm flipH="1">
            <a:off x="7374212" y="240969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오른쪽 화살표 10"/>
          <p:cNvSpPr/>
          <p:nvPr/>
        </p:nvSpPr>
        <p:spPr>
          <a:xfrm flipH="1">
            <a:off x="7408487" y="3841666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4766112" y="3751596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766111" y="403444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85295" y="198502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 -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385297" y="2515604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 -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572531" y="4699968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 -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72530" y="588548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0 -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32870" y="1052060"/>
            <a:ext cx="1401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RT3 whole lysate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17642" y="3232358"/>
            <a:ext cx="1431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RT3 mitochondria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1149" y="4149370"/>
            <a:ext cx="10631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RT3 cytosol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17642" y="5262893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242329" y="1125233"/>
            <a:ext cx="13933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242329" y="2899011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06738" y="607913"/>
            <a:ext cx="463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1</a:t>
            </a:r>
            <a:r>
              <a:rPr lang="en-US" altLang="ko-KR" dirty="0" smtClean="0"/>
              <a:t>A</a:t>
            </a:r>
            <a:endParaRPr lang="ko-KR" altLang="en-US" dirty="0"/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7932" y="2956744"/>
            <a:ext cx="2657856" cy="1231392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7931" y="4629276"/>
            <a:ext cx="2805031" cy="1984991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89748" y="1287260"/>
            <a:ext cx="2606040" cy="1228344"/>
          </a:xfrm>
          <a:prstGeom prst="rect">
            <a:avLst/>
          </a:prstGeom>
        </p:spPr>
      </p:pic>
      <p:sp>
        <p:nvSpPr>
          <p:cNvPr id="27" name="오른쪽 화살표 26"/>
          <p:cNvSpPr/>
          <p:nvPr/>
        </p:nvSpPr>
        <p:spPr>
          <a:xfrm flipH="1">
            <a:off x="11398962" y="2148760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오른쪽 화살표 27"/>
          <p:cNvSpPr/>
          <p:nvPr/>
        </p:nvSpPr>
        <p:spPr>
          <a:xfrm flipH="1">
            <a:off x="11251788" y="3597554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오른쪽 화살표 28"/>
          <p:cNvSpPr/>
          <p:nvPr/>
        </p:nvSpPr>
        <p:spPr>
          <a:xfrm flipH="1">
            <a:off x="11526480" y="6029244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" name="TextBox 29"/>
          <p:cNvSpPr txBox="1"/>
          <p:nvPr/>
        </p:nvSpPr>
        <p:spPr>
          <a:xfrm>
            <a:off x="9224399" y="198706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9231365" y="216306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9392473" y="548234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411633" y="584620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9392472" y="5167262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135570" y="3805156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135569" y="3945452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9065897" y="3513629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9205237" y="316317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098040" y="867394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B</a:t>
            </a:r>
            <a:endParaRPr lang="ko-KR" altLang="en-US" dirty="0"/>
          </a:p>
        </p:txBody>
      </p:sp>
      <p:sp>
        <p:nvSpPr>
          <p:cNvPr id="40" name="TextBox 39"/>
          <p:cNvSpPr txBox="1"/>
          <p:nvPr/>
        </p:nvSpPr>
        <p:spPr>
          <a:xfrm>
            <a:off x="8714968" y="978882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688385" y="2653152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DAC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688384" y="431633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9817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6920" y="4370832"/>
            <a:ext cx="3139440" cy="94488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6920" y="2956560"/>
            <a:ext cx="3044952" cy="117957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6920" y="1207008"/>
            <a:ext cx="3139440" cy="1514856"/>
          </a:xfrm>
          <a:prstGeom prst="rect">
            <a:avLst/>
          </a:prstGeom>
        </p:spPr>
      </p:pic>
      <p:sp>
        <p:nvSpPr>
          <p:cNvPr id="6" name="오른쪽 화살표 5"/>
          <p:cNvSpPr/>
          <p:nvPr/>
        </p:nvSpPr>
        <p:spPr>
          <a:xfrm flipH="1">
            <a:off x="4910454" y="2344782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오른쪽 화살표 6"/>
          <p:cNvSpPr/>
          <p:nvPr/>
        </p:nvSpPr>
        <p:spPr>
          <a:xfrm flipH="1">
            <a:off x="4864581" y="330272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오른쪽 화살표 7"/>
          <p:cNvSpPr/>
          <p:nvPr/>
        </p:nvSpPr>
        <p:spPr>
          <a:xfrm flipH="1">
            <a:off x="4999872" y="4780563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テキスト ボックス 38">
            <a:extLst>
              <a:ext uri="{FF2B5EF4-FFF2-40B4-BE49-F238E27FC236}">
                <a16:creationId xmlns:a16="http://schemas.microsoft.com/office/drawing/2014/main" id="{D1AA24D9-D7F2-41C5-4713-E26C14A7F900}"/>
              </a:ext>
            </a:extLst>
          </p:cNvPr>
          <p:cNvSpPr txBox="1"/>
          <p:nvPr/>
        </p:nvSpPr>
        <p:spPr>
          <a:xfrm>
            <a:off x="0" y="6009"/>
            <a:ext cx="8834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.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ginal blots of westerns 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ko-KR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ko-KR" altLang="en-US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4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A &amp; 2B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US" altLang="ja-JP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927225" y="599704"/>
            <a:ext cx="463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A</a:t>
            </a:r>
            <a:endParaRPr lang="ko-KR" altLang="en-US" dirty="0"/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8756" y="5460862"/>
            <a:ext cx="2929128" cy="1103376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8756" y="4252296"/>
            <a:ext cx="2843784" cy="917448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8756" y="2608368"/>
            <a:ext cx="2819400" cy="1292352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0468" y="832974"/>
            <a:ext cx="2837688" cy="1511808"/>
          </a:xfrm>
          <a:prstGeom prst="rect">
            <a:avLst/>
          </a:prstGeom>
        </p:spPr>
      </p:pic>
      <p:sp>
        <p:nvSpPr>
          <p:cNvPr id="20" name="오른쪽 화살표 19"/>
          <p:cNvSpPr/>
          <p:nvPr/>
        </p:nvSpPr>
        <p:spPr>
          <a:xfrm flipH="1">
            <a:off x="9414156" y="3418668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오른쪽 화살표 20"/>
          <p:cNvSpPr/>
          <p:nvPr/>
        </p:nvSpPr>
        <p:spPr>
          <a:xfrm flipH="1">
            <a:off x="9414437" y="1929604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TextBox 21"/>
          <p:cNvSpPr txBox="1"/>
          <p:nvPr/>
        </p:nvSpPr>
        <p:spPr>
          <a:xfrm>
            <a:off x="6897561" y="1779585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897561" y="1983604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878400" y="1631135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925990" y="576880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오른쪽 화살표 25"/>
          <p:cNvSpPr/>
          <p:nvPr/>
        </p:nvSpPr>
        <p:spPr>
          <a:xfrm flipH="1">
            <a:off x="9523884" y="582252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6977029" y="3146870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957868" y="3418668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957868" y="2911334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오른쪽 화살표 29"/>
          <p:cNvSpPr/>
          <p:nvPr/>
        </p:nvSpPr>
        <p:spPr>
          <a:xfrm flipH="1">
            <a:off x="9455957" y="4802579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TextBox 30"/>
          <p:cNvSpPr txBox="1"/>
          <p:nvPr/>
        </p:nvSpPr>
        <p:spPr>
          <a:xfrm>
            <a:off x="6955100" y="492878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927230" y="465841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955100" y="447877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894653" y="4240802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878399" y="140361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878399" y="152599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611501" y="262518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B</a:t>
            </a:r>
            <a:endParaRPr lang="ko-KR" alt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1879638" y="942122"/>
            <a:ext cx="13933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927225" y="2728890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701946" y="583384"/>
            <a:ext cx="6671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l-GR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971320" y="4114964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684609" y="2346758"/>
            <a:ext cx="7922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MPK</a:t>
            </a:r>
            <a:r>
              <a:rPr lang="el-GR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695339" y="3984159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658057" y="5210665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67661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C3615044-DC8C-4F1A-BE0A-155DF9ACC80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/>
          </a:blip>
          <a:srcRect l="5458" t="-3003" r="39267" b="74186"/>
          <a:stretch/>
        </p:blipFill>
        <p:spPr>
          <a:xfrm>
            <a:off x="5805868" y="1410438"/>
            <a:ext cx="4192906" cy="1337272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D50539B2-FC79-4F54-BF00-9F3E8029F67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/>
          </a:blip>
          <a:srcRect l="9381" t="27915" r="40198" b="47733"/>
          <a:stretch/>
        </p:blipFill>
        <p:spPr>
          <a:xfrm>
            <a:off x="5753480" y="2747710"/>
            <a:ext cx="4297682" cy="1672854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2DD658BB-A2E7-4D18-B300-68D2CBF829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/>
          </a:blip>
          <a:srcRect l="11644" t="59942" r="36219" b="19164"/>
          <a:stretch/>
        </p:blipFill>
        <p:spPr>
          <a:xfrm>
            <a:off x="5600700" y="4723333"/>
            <a:ext cx="4955287" cy="108972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54468" y="845866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</a:t>
            </a:r>
            <a:r>
              <a:rPr lang="en-US" altLang="ko-KR" dirty="0"/>
              <a:t>B</a:t>
            </a:r>
            <a:endParaRPr lang="ko-KR" altLang="en-US" dirty="0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272" y="3071660"/>
            <a:ext cx="2764536" cy="1118616"/>
          </a:xfrm>
          <a:prstGeom prst="rect">
            <a:avLst/>
          </a:prstGeom>
        </p:spPr>
      </p:pic>
      <p:sp>
        <p:nvSpPr>
          <p:cNvPr id="7" name="오른쪽 화살표 6"/>
          <p:cNvSpPr/>
          <p:nvPr/>
        </p:nvSpPr>
        <p:spPr>
          <a:xfrm flipH="1">
            <a:off x="4501696" y="365709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TextBox 7"/>
          <p:cNvSpPr txBox="1"/>
          <p:nvPr/>
        </p:nvSpPr>
        <p:spPr>
          <a:xfrm>
            <a:off x="2215133" y="3584137"/>
            <a:ext cx="37446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15133" y="3765095"/>
            <a:ext cx="3744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272" y="4534590"/>
            <a:ext cx="3081528" cy="103632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272" y="1453282"/>
            <a:ext cx="2947416" cy="1274064"/>
          </a:xfrm>
          <a:prstGeom prst="rect">
            <a:avLst/>
          </a:prstGeom>
        </p:spPr>
      </p:pic>
      <p:sp>
        <p:nvSpPr>
          <p:cNvPr id="12" name="오른쪽 화살표 11"/>
          <p:cNvSpPr/>
          <p:nvPr/>
        </p:nvSpPr>
        <p:spPr>
          <a:xfrm flipH="1">
            <a:off x="4716672" y="2281996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TextBox 12"/>
          <p:cNvSpPr txBox="1"/>
          <p:nvPr/>
        </p:nvSpPr>
        <p:spPr>
          <a:xfrm>
            <a:off x="2258678" y="1759692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354473" y="2027736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89153" y="2223680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297864" y="2406565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402367" y="5052750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오른쪽 화살표 17"/>
          <p:cNvSpPr/>
          <p:nvPr/>
        </p:nvSpPr>
        <p:spPr>
          <a:xfrm flipH="1">
            <a:off x="4903688" y="5123890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TextBox 18"/>
          <p:cNvSpPr txBox="1"/>
          <p:nvPr/>
        </p:nvSpPr>
        <p:spPr>
          <a:xfrm>
            <a:off x="6977417" y="515038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 -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164651" y="349565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 -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871102" y="845866"/>
            <a:ext cx="457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C</a:t>
            </a:r>
            <a:endParaRPr lang="ko-KR" altLang="en-US" dirty="0"/>
          </a:p>
        </p:txBody>
      </p:sp>
      <p:sp>
        <p:nvSpPr>
          <p:cNvPr id="22" name="오른쪽 화살표 21"/>
          <p:cNvSpPr/>
          <p:nvPr/>
        </p:nvSpPr>
        <p:spPr>
          <a:xfrm flipH="1">
            <a:off x="9479565" y="2036314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오른쪽 화살표 22"/>
          <p:cNvSpPr/>
          <p:nvPr/>
        </p:nvSpPr>
        <p:spPr>
          <a:xfrm flipH="1">
            <a:off x="9623565" y="3576968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오른쪽 화살표 23"/>
          <p:cNvSpPr/>
          <p:nvPr/>
        </p:nvSpPr>
        <p:spPr>
          <a:xfrm flipH="1">
            <a:off x="9695565" y="522508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TextBox 24"/>
          <p:cNvSpPr txBox="1"/>
          <p:nvPr/>
        </p:nvSpPr>
        <p:spPr>
          <a:xfrm>
            <a:off x="1903884" y="1190180"/>
            <a:ext cx="13933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927225" y="2728890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946384" y="4267600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665895" y="4530174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770090" y="2597905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871101" y="1215198"/>
            <a:ext cx="11869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chome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8">
            <a:extLst>
              <a:ext uri="{FF2B5EF4-FFF2-40B4-BE49-F238E27FC236}">
                <a16:creationId xmlns:a16="http://schemas.microsoft.com/office/drawing/2014/main" id="{D1AA24D9-D7F2-41C5-4713-E26C14A7F900}"/>
              </a:ext>
            </a:extLst>
          </p:cNvPr>
          <p:cNvSpPr txBox="1"/>
          <p:nvPr/>
        </p:nvSpPr>
        <p:spPr>
          <a:xfrm>
            <a:off x="0" y="6009"/>
            <a:ext cx="8834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.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ginal blots of westerns 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ko-KR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ko-KR" altLang="en-US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4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ko-KR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ko-KR" sz="14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amp; 3C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US" altLang="ja-JP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29325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내용 개체 틀 4">
            <a:extLst>
              <a:ext uri="{FF2B5EF4-FFF2-40B4-BE49-F238E27FC236}">
                <a16:creationId xmlns:a16="http://schemas.microsoft.com/office/drawing/2014/main" id="{760A3558-99C0-41CC-9621-37D808A3CC6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67" t="43553" r="42799" b="49725"/>
          <a:stretch/>
        </p:blipFill>
        <p:spPr>
          <a:xfrm>
            <a:off x="1888768" y="1467388"/>
            <a:ext cx="3416060" cy="677385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9A779158-E32F-4D56-8B4B-A61F11C696A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580" t="-28" r="41973" b="86320"/>
          <a:stretch/>
        </p:blipFill>
        <p:spPr>
          <a:xfrm>
            <a:off x="1908982" y="2496216"/>
            <a:ext cx="3395846" cy="1086928"/>
          </a:xfrm>
          <a:prstGeom prst="rect">
            <a:avLst/>
          </a:prstGeom>
        </p:spPr>
      </p:pic>
      <p:pic>
        <p:nvPicPr>
          <p:cNvPr id="11" name="내용 개체 틀 4">
            <a:extLst>
              <a:ext uri="{FF2B5EF4-FFF2-40B4-BE49-F238E27FC236}">
                <a16:creationId xmlns:a16="http://schemas.microsoft.com/office/drawing/2014/main" id="{450EA130-8E15-4360-A4D2-86FBDD0EE99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520" t="38565" r="76" b="48900"/>
          <a:stretch/>
        </p:blipFill>
        <p:spPr>
          <a:xfrm>
            <a:off x="1908982" y="3833764"/>
            <a:ext cx="3510950" cy="1757274"/>
          </a:xfrm>
          <a:prstGeom prst="rect">
            <a:avLst/>
          </a:prstGeom>
        </p:spPr>
      </p:pic>
      <p:pic>
        <p:nvPicPr>
          <p:cNvPr id="14" name="내용 개체 틀 4">
            <a:extLst>
              <a:ext uri="{FF2B5EF4-FFF2-40B4-BE49-F238E27FC236}">
                <a16:creationId xmlns:a16="http://schemas.microsoft.com/office/drawing/2014/main" id="{4E10BEDF-0C4E-4341-8A43-465E5A089E8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5" t="66322" r="42333" b="21421"/>
          <a:stretch/>
        </p:blipFill>
        <p:spPr>
          <a:xfrm>
            <a:off x="6555377" y="2497800"/>
            <a:ext cx="3416062" cy="1117857"/>
          </a:xfrm>
          <a:prstGeom prst="rect">
            <a:avLst/>
          </a:prstGeom>
        </p:spPr>
      </p:pic>
      <p:sp>
        <p:nvSpPr>
          <p:cNvPr id="15" name="오른쪽 화살표 14"/>
          <p:cNvSpPr/>
          <p:nvPr/>
        </p:nvSpPr>
        <p:spPr>
          <a:xfrm flipH="1">
            <a:off x="9432844" y="3056728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テキスト ボックス 38">
            <a:extLst>
              <a:ext uri="{FF2B5EF4-FFF2-40B4-BE49-F238E27FC236}">
                <a16:creationId xmlns:a16="http://schemas.microsoft.com/office/drawing/2014/main" id="{D1AA24D9-D7F2-41C5-4713-E26C14A7F900}"/>
              </a:ext>
            </a:extLst>
          </p:cNvPr>
          <p:cNvSpPr txBox="1"/>
          <p:nvPr/>
        </p:nvSpPr>
        <p:spPr>
          <a:xfrm>
            <a:off x="0" y="6009"/>
            <a:ext cx="8834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.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ginal blots of westerns 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ko-KR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ko-KR" altLang="en-US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4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D &amp; 3E.</a:t>
            </a:r>
            <a:endParaRPr lang="en-US" altLang="ja-JP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4780" y="5348782"/>
            <a:ext cx="2798064" cy="935736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6760" y="3834674"/>
            <a:ext cx="3246120" cy="1264920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1248" y="1256065"/>
            <a:ext cx="3151632" cy="984504"/>
          </a:xfrm>
          <a:prstGeom prst="rect">
            <a:avLst/>
          </a:prstGeom>
        </p:spPr>
      </p:pic>
      <p:sp>
        <p:nvSpPr>
          <p:cNvPr id="19" name="오른쪽 화살표 18"/>
          <p:cNvSpPr/>
          <p:nvPr/>
        </p:nvSpPr>
        <p:spPr>
          <a:xfrm flipH="1">
            <a:off x="9690880" y="4496548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오른쪽 화살표 19"/>
          <p:cNvSpPr/>
          <p:nvPr/>
        </p:nvSpPr>
        <p:spPr>
          <a:xfrm flipH="1">
            <a:off x="9658096" y="1748317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7125782" y="1393536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133403" y="164738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815774" y="5816650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오른쪽 화살표 23"/>
          <p:cNvSpPr/>
          <p:nvPr/>
        </p:nvSpPr>
        <p:spPr>
          <a:xfrm flipH="1">
            <a:off x="9360844" y="5863133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TextBox 24"/>
          <p:cNvSpPr txBox="1"/>
          <p:nvPr/>
        </p:nvSpPr>
        <p:spPr>
          <a:xfrm>
            <a:off x="6903493" y="4449785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911114" y="4703632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666178" y="3192929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 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236731" y="164087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236730" y="484966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0 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오른쪽 화살표 29"/>
          <p:cNvSpPr/>
          <p:nvPr/>
        </p:nvSpPr>
        <p:spPr>
          <a:xfrm flipH="1">
            <a:off x="4212240" y="1682077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오른쪽 화살표 30"/>
          <p:cNvSpPr/>
          <p:nvPr/>
        </p:nvSpPr>
        <p:spPr>
          <a:xfrm flipH="1">
            <a:off x="4936340" y="3237879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오른쪽 화살표 31"/>
          <p:cNvSpPr/>
          <p:nvPr/>
        </p:nvSpPr>
        <p:spPr>
          <a:xfrm flipH="1">
            <a:off x="4678965" y="4884329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1826075" y="851726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</a:t>
            </a:r>
            <a:r>
              <a:rPr lang="en-US" altLang="ko-KR" dirty="0"/>
              <a:t>D</a:t>
            </a:r>
            <a:endParaRPr lang="ko-KR" alt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6565302" y="569789"/>
            <a:ext cx="429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E</a:t>
            </a:r>
            <a:endParaRPr lang="ko-KR" alt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1880500" y="3587848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831793" y="2224352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OD2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837376" y="1208455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618413" y="974031"/>
            <a:ext cx="6671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l-GR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608608" y="2236064"/>
            <a:ext cx="7922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MPK</a:t>
            </a:r>
            <a:r>
              <a:rPr lang="el-GR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535505" y="3632762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608608" y="5073768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9827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38">
            <a:extLst>
              <a:ext uri="{FF2B5EF4-FFF2-40B4-BE49-F238E27FC236}">
                <a16:creationId xmlns:a16="http://schemas.microsoft.com/office/drawing/2014/main" id="{D1AA24D9-D7F2-41C5-4713-E26C14A7F900}"/>
              </a:ext>
            </a:extLst>
          </p:cNvPr>
          <p:cNvSpPr txBox="1"/>
          <p:nvPr/>
        </p:nvSpPr>
        <p:spPr>
          <a:xfrm>
            <a:off x="0" y="6009"/>
            <a:ext cx="8834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.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ginal blots of westerns 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ko-KR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ko-KR" altLang="en-US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4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B.</a:t>
            </a:r>
            <a:endParaRPr lang="en-US" altLang="ja-JP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7724" y="4710683"/>
            <a:ext cx="3788664" cy="1216152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6247" y="1562575"/>
            <a:ext cx="3898392" cy="1331976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6247" y="3171069"/>
            <a:ext cx="3502152" cy="1228344"/>
          </a:xfrm>
          <a:prstGeom prst="rect">
            <a:avLst/>
          </a:prstGeom>
        </p:spPr>
      </p:pic>
      <p:sp>
        <p:nvSpPr>
          <p:cNvPr id="19" name="오른쪽 화살표 18"/>
          <p:cNvSpPr/>
          <p:nvPr/>
        </p:nvSpPr>
        <p:spPr>
          <a:xfrm flipH="1">
            <a:off x="7804388" y="234965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오른쪽 화살표 19"/>
          <p:cNvSpPr/>
          <p:nvPr/>
        </p:nvSpPr>
        <p:spPr>
          <a:xfrm flipH="1">
            <a:off x="7462268" y="3973960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4526989" y="3594026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499120" y="3760825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443382" y="3920238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438152" y="4125925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683898" y="5370375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오른쪽 화살표 25"/>
          <p:cNvSpPr/>
          <p:nvPr/>
        </p:nvSpPr>
        <p:spPr>
          <a:xfrm flipH="1">
            <a:off x="7832257" y="537352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4620652" y="1827669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537874" y="2093618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576191" y="229593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600242" y="168307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992196" y="966878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4B</a:t>
            </a:r>
            <a:endParaRPr lang="ko-KR" alt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3992196" y="1316173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017558" y="2944969"/>
            <a:ext cx="13933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087724" y="4442960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50250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7288" y="5034992"/>
            <a:ext cx="3706368" cy="98145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7288" y="3692113"/>
            <a:ext cx="4184904" cy="1078992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7288" y="2117586"/>
            <a:ext cx="3855720" cy="131064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8525" y="3621567"/>
            <a:ext cx="3959352" cy="1109472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7314" y="2117586"/>
            <a:ext cx="3608832" cy="1127760"/>
          </a:xfrm>
          <a:prstGeom prst="rect">
            <a:avLst/>
          </a:prstGeom>
        </p:spPr>
      </p:pic>
      <p:sp>
        <p:nvSpPr>
          <p:cNvPr id="9" name="오른쪽 화살표 8"/>
          <p:cNvSpPr/>
          <p:nvPr/>
        </p:nvSpPr>
        <p:spPr>
          <a:xfrm flipH="1">
            <a:off x="10568824" y="2718906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오른쪽 화살표 9"/>
          <p:cNvSpPr/>
          <p:nvPr/>
        </p:nvSpPr>
        <p:spPr>
          <a:xfrm flipH="1">
            <a:off x="4875194" y="2668998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1794845" y="2364312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820972" y="2513976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14876" y="2677279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814876" y="2910366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648539" y="417630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오른쪽 화살표 15"/>
          <p:cNvSpPr/>
          <p:nvPr/>
        </p:nvSpPr>
        <p:spPr>
          <a:xfrm flipH="1">
            <a:off x="10918192" y="4278798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오른쪽 화살표 16"/>
          <p:cNvSpPr/>
          <p:nvPr/>
        </p:nvSpPr>
        <p:spPr>
          <a:xfrm flipH="1">
            <a:off x="5223877" y="4104885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오른쪽 화살표 17"/>
          <p:cNvSpPr/>
          <p:nvPr/>
        </p:nvSpPr>
        <p:spPr>
          <a:xfrm flipH="1">
            <a:off x="10500952" y="5525720"/>
            <a:ext cx="144000" cy="108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TextBox 18"/>
          <p:cNvSpPr txBox="1"/>
          <p:nvPr/>
        </p:nvSpPr>
        <p:spPr>
          <a:xfrm>
            <a:off x="7100259" y="5417998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100258" y="571250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218323" y="421026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197425" y="4040721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197425" y="3897907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217793" y="2370202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243920" y="2706719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223022" y="253717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217908" y="2227388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218323" y="3763453"/>
            <a:ext cx="374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348889" y="1470886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5</a:t>
            </a:r>
            <a:r>
              <a:rPr lang="en-US" altLang="ko-KR" dirty="0" smtClean="0"/>
              <a:t>B</a:t>
            </a:r>
            <a:endParaRPr lang="ko-KR" alt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1348889" y="1833243"/>
            <a:ext cx="13933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434489" y="3323698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773594" y="4790866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93962" y="3428226"/>
            <a:ext cx="5629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RP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871400" y="1808314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FN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8">
            <a:extLst>
              <a:ext uri="{FF2B5EF4-FFF2-40B4-BE49-F238E27FC236}">
                <a16:creationId xmlns:a16="http://schemas.microsoft.com/office/drawing/2014/main" id="{D1AA24D9-D7F2-41C5-4713-E26C14A7F900}"/>
              </a:ext>
            </a:extLst>
          </p:cNvPr>
          <p:cNvSpPr txBox="1"/>
          <p:nvPr/>
        </p:nvSpPr>
        <p:spPr>
          <a:xfrm>
            <a:off x="0" y="6009"/>
            <a:ext cx="8834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.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iginal blots of westerns </a:t>
            </a:r>
            <a:r>
              <a:rPr lang="en-US" altLang="ja-JP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ko-KR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ko-KR" altLang="en-US" sz="140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ko-KR" sz="14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</a:t>
            </a:r>
            <a:endParaRPr lang="en-US" altLang="ja-JP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318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</TotalTime>
  <Words>276</Words>
  <Application>Microsoft Office PowerPoint</Application>
  <PresentationFormat>와이드스크린</PresentationFormat>
  <Paragraphs>128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2" baseType="lpstr">
      <vt:lpstr>宋体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njee</dc:creator>
  <cp:lastModifiedBy>kumc</cp:lastModifiedBy>
  <cp:revision>22</cp:revision>
  <dcterms:created xsi:type="dcterms:W3CDTF">2023-07-26T08:22:07Z</dcterms:created>
  <dcterms:modified xsi:type="dcterms:W3CDTF">2024-04-12T09:14:46Z</dcterms:modified>
</cp:coreProperties>
</file>